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4ADBFA-7385-446A-9E57-D913C41E21D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D7773-2C05-4F6D-903D-8901747061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571342-62E4-45CA-AA7A-DC5063F8D1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DEF38E-13D9-4614-947B-8E19AA778E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C3AD9-0C6B-4EF3-AB32-E3608E9818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8E2BB2-379E-4731-B095-56D13FA615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9551ED-2D2F-42F2-8D70-EA07140DC1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5F5605-A3AF-4307-8BF1-1EBB8B4FFD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75D878-2EAE-45F4-A78F-356786A8A3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97B6B3-A7AC-458B-B990-88CABD8D9B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4BE83F-9271-42A8-AA7B-03A02263D7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C3ED2F-0C90-4F72-A89E-AD36439268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E706D40-FC3F-4BB0-8040-68D120A531C6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11280" y="1197000"/>
            <a:ext cx="280836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otentially relevant RCTs identified and screened for retrieval (n=10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611280" y="2085840"/>
            <a:ext cx="280836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CTs retrieved for more detailed evaluation (n=8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611280" y="2922480"/>
            <a:ext cx="280836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otentially appropriate RCTs to be included in the meta-analysis (n=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11280" y="3794040"/>
            <a:ext cx="280836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CTs included in meta-analysis (n=5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611280" y="5211720"/>
            <a:ext cx="280836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72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CTs with usable information by outcome (n=5, but 2 partial exclusion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967200" y="1444680"/>
            <a:ext cx="3159000" cy="64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CTs excluded (n=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eason: Revie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             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Not randomiz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965400" y="3232080"/>
            <a:ext cx="3159360" cy="64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CTs excluded (n=1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eason: Analysis not adjusted for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luster design [22]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967200" y="4130640"/>
            <a:ext cx="3159000" cy="21016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54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CTs excluded (n=2 partially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eason: Dichotomous outcomes excluded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ecause analysis was not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djusted for cluster design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ontinuous outcomes included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n=1) [25]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             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hree-arm study of which th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No-Net control arm wa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excluded because they were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upplied with ITNs by a third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arty during study (n=1) [23]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9" name=""/>
          <p:cNvCxnSpPr>
            <a:stCxn id="41" idx="2"/>
            <a:endCxn id="42" idx="0"/>
          </p:cNvCxnSpPr>
          <p:nvPr/>
        </p:nvCxnSpPr>
        <p:spPr>
          <a:xfrm>
            <a:off x="2015280" y="1656000"/>
            <a:ext cx="360" cy="430200"/>
          </a:xfrm>
          <a:prstGeom prst="straightConnector1">
            <a:avLst/>
          </a:prstGeom>
          <a:ln w="1584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0" name=""/>
          <p:cNvCxnSpPr>
            <a:stCxn id="42" idx="2"/>
            <a:endCxn id="43" idx="0"/>
          </p:cNvCxnSpPr>
          <p:nvPr/>
        </p:nvCxnSpPr>
        <p:spPr>
          <a:xfrm>
            <a:off x="2015280" y="2544840"/>
            <a:ext cx="360" cy="378000"/>
          </a:xfrm>
          <a:prstGeom prst="straightConnector1">
            <a:avLst/>
          </a:prstGeom>
          <a:ln w="1584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1" name=""/>
          <p:cNvCxnSpPr>
            <a:stCxn id="43" idx="2"/>
            <a:endCxn id="44" idx="0"/>
          </p:cNvCxnSpPr>
          <p:nvPr/>
        </p:nvCxnSpPr>
        <p:spPr>
          <a:xfrm>
            <a:off x="2015280" y="3381480"/>
            <a:ext cx="360" cy="412920"/>
          </a:xfrm>
          <a:prstGeom prst="straightConnector1">
            <a:avLst/>
          </a:prstGeom>
          <a:ln w="1584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2" name=""/>
          <p:cNvCxnSpPr>
            <a:stCxn id="44" idx="2"/>
            <a:endCxn id="45" idx="0"/>
          </p:cNvCxnSpPr>
          <p:nvPr/>
        </p:nvCxnSpPr>
        <p:spPr>
          <a:xfrm>
            <a:off x="2015280" y="4253040"/>
            <a:ext cx="360" cy="959040"/>
          </a:xfrm>
          <a:prstGeom prst="straightConnector1">
            <a:avLst/>
          </a:prstGeom>
          <a:ln w="1584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3" name=""/>
          <p:cNvSpPr/>
          <p:nvPr/>
        </p:nvSpPr>
        <p:spPr>
          <a:xfrm>
            <a:off x="2014560" y="4724280"/>
            <a:ext cx="1944720" cy="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013120" y="3573360"/>
            <a:ext cx="1944360" cy="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016000" y="1857240"/>
            <a:ext cx="1944720" cy="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968640" y="2357280"/>
            <a:ext cx="3159360" cy="6415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CTs excluded (n=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eason: two publications reporting results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rom same main stud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016000" y="2698920"/>
            <a:ext cx="1944720" cy="0"/>
          </a:xfrm>
          <a:prstGeom prst="line">
            <a:avLst/>
          </a:prstGeom>
          <a:ln w="1584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04T15:31:44Z</dcterms:created>
  <dc:creator>Feiko ter Kuile</dc:creator>
  <dc:description/>
  <dc:language>en-US</dc:language>
  <cp:lastModifiedBy>Feiko ter Kuile</cp:lastModifiedBy>
  <dcterms:modified xsi:type="dcterms:W3CDTF">2007-01-26T13:49:55Z</dcterms:modified>
  <cp:revision>7</cp:revision>
  <dc:subject/>
  <dc:title>Slide 1</dc:title>
</cp:coreProperties>
</file>